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50"/>
    <p:restoredTop sz="94631"/>
  </p:normalViewPr>
  <p:slideViewPr>
    <p:cSldViewPr snapToGrid="0" snapToObjects="1">
      <p:cViewPr varScale="1">
        <p:scale>
          <a:sx n="56" d="100"/>
          <a:sy n="56" d="100"/>
        </p:scale>
        <p:origin x="-108" y="-120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C98CF28-9CD7-2249-9E4A-2C83761111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83E10579-9222-B04A-BA56-BB6FC27E21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2F56603-55EA-7C4F-8C17-0DB2F064B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5F015-8014-E347-AF8A-08E938C1DBC7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F62617E-8072-194E-9546-F43E40370A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05A14F2-E192-EF43-A0FF-FC5DE26C20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D6FB4-DDDA-AC44-BDC7-9E219995B6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049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EF57271-690B-B843-8AC9-AB84B47012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5B6672BC-A3C3-7543-8AF1-91CD2AA2B3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465BCC0-5770-204A-BE38-47C2EABA00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5F015-8014-E347-AF8A-08E938C1DBC7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8C1E12A-05EA-094A-AA2D-42A1340ED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D11F290-7B00-BD43-925C-C391B4B105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D6FB4-DDDA-AC44-BDC7-9E219995B6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267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67AE6664-A645-1B4C-94BC-AD6A160B5F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D32EFEF-63A1-9846-A062-2B40EBAAFE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EF8189E-77F6-F348-A26E-9C4C88643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5F015-8014-E347-AF8A-08E938C1DBC7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BFC7FAB-CD27-0E44-93C3-0476D6AE20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82335C2-3957-F149-B001-0376FAD551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D6FB4-DDDA-AC44-BDC7-9E219995B6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124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8EE4CF1-FE33-B848-83A5-F923AAA810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C54F409-26E5-3A49-AE04-9B81F0A9FF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02A1A6F-3F28-D346-97F8-518BB38A14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5F015-8014-E347-AF8A-08E938C1DBC7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53E0BE5-63BC-7A4D-8137-FF91EC8E98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F866611-34C1-524C-8F9B-78C37D67DE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D6FB4-DDDA-AC44-BDC7-9E219995B6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5640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CDA441A-9F12-114D-B599-29FE5B4A8B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146C6EB-6F53-F048-ACAE-955FA681AB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09057C8-8A49-5046-8D6B-5B197F5B5F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5F015-8014-E347-AF8A-08E938C1DBC7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4B0B482-1619-794A-BABF-57BCFD11BC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00DB668-778A-ED47-9186-8DFAC8AB4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D6FB4-DDDA-AC44-BDC7-9E219995B6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56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FF298E1-224A-B140-8EAD-C9625C2EA1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87BF567-36B2-CA41-86A6-F882FC412B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EA21D419-89D3-0341-8E6C-D296805345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4F83173-99EF-EC46-B944-668D4F650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5F015-8014-E347-AF8A-08E938C1DBC7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CD808D3E-8E7C-D045-A4C9-3AD69AA11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1A9D26A-0BF7-C647-8885-743FDABDFC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D6FB4-DDDA-AC44-BDC7-9E219995B6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051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7A9868D-291E-2A42-887E-A1B513132B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C38AD3C-6F27-B648-8F22-C53B444589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C5A7E838-98EC-E943-8DAF-1BA36E3E83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C1119582-A65A-2148-A7A5-6E019A2AD5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4A403521-2BBC-E644-9194-661BAEF774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899A3B57-8DD9-0247-8F12-7A171856A3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5F015-8014-E347-AF8A-08E938C1DBC7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C6F746A9-343C-1C4C-A727-85801E1A7A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87B69578-C9C7-B046-926B-6DBAFF829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D6FB4-DDDA-AC44-BDC7-9E219995B6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546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6120D8D-E7C5-CD46-B16F-B71CE933E1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AE66F8C9-B020-AE4C-AD0B-8BE39F5147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5F015-8014-E347-AF8A-08E938C1DBC7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5EEC50FF-85AF-974D-8CA1-189D5BAF4F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73367843-2790-7449-8636-9CE2AED089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D6FB4-DDDA-AC44-BDC7-9E219995B6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1611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699C7825-9C09-8641-9DBF-8ECF8EB0C6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5F015-8014-E347-AF8A-08E938C1DBC7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ABC91A01-F7DF-FA47-85E1-495096E10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DC2439BA-F7A3-094F-B972-842B9F327C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D6FB4-DDDA-AC44-BDC7-9E219995B6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734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EB35080-D5AF-444C-8297-6BE73126B6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15CFF30-E311-AE49-844E-E860D2027D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93463DEF-AA9F-F74B-A2DB-573B70B20D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62E7F0D-4589-844B-9C3D-9F44CF3450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5F015-8014-E347-AF8A-08E938C1DBC7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53EAEB1-616F-E942-84CB-A97ABE98C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E766B483-687A-F947-9DB8-B063FEF99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D6FB4-DDDA-AC44-BDC7-9E219995B6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669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B8E7BB5-CBC9-2441-989C-869E3C2804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123BD5E6-831B-C940-8C9B-F2C0ADBD1A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8DDF5D4-C13C-E041-A09B-07E896CA24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425B573-8CE6-7641-9485-734F097AD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5F015-8014-E347-AF8A-08E938C1DBC7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CAA13375-0668-2748-808A-CADF66CA6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DDD24CAF-1BA3-2C40-BF7F-1B51A272A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D6FB4-DDDA-AC44-BDC7-9E219995B6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500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8B71CE15-62BA-8441-A09D-C2EB017534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2495A128-B911-B240-85B0-DDC62CFADE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B23850F-2352-E544-99A2-141ABB310F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65F015-8014-E347-AF8A-08E938C1DBC7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6ECE3FF-262A-4743-9177-6C5F0B9E9B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4F35EBC-80DD-6848-85A3-8CE30422F9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ED6FB4-DDDA-AC44-BDC7-9E219995B6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544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file:////Users/joshuakwon/OneDrive%20-%20&#4361;&#4453;&#4363;&#4462;&#4527;&#4355;&#4450;&#4370;&#4449;&#4520;&#4352;&#4461;/Publications/2018/NGS_SNPanalyzer/PeerJ/Figures/&#4361;&#4467;&#4367;&#4467;&#4357;&#4469;&#4523;&#4361;&#4451;&#4538;/main.PNG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file:////Users/joshuakwon/OneDrive%20-%20&#4361;&#4453;&#4363;&#4462;&#4527;&#4355;&#4450;&#4370;&#4449;&#4520;&#4352;&#4461;/Publications/2018/NGS_SNPanalyzer/PeerJ/Figures/IMG_5782.jpg" TargetMode="External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7679517C-B58A-1B41-83A1-B2E80DDF7725}"/>
              </a:ext>
            </a:extLst>
          </p:cNvPr>
          <p:cNvPicPr>
            <a:picLocks noChangeAspect="1"/>
          </p:cNvPicPr>
          <p:nvPr/>
        </p:nvPicPr>
        <p:blipFill>
          <a:blip r:embed="rId2" r:link="rId3"/>
          <a:stretch>
            <a:fillRect/>
          </a:stretch>
        </p:blipFill>
        <p:spPr>
          <a:xfrm>
            <a:off x="372534" y="1"/>
            <a:ext cx="11446933" cy="620459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03200" y="6317735"/>
            <a:ext cx="3369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 smtClean="0"/>
              <a:t>a</a:t>
            </a:r>
            <a:endParaRPr lang="ko-KR" altLang="en-US" sz="2400" b="1" dirty="0"/>
          </a:p>
        </p:txBody>
      </p:sp>
      <p:sp>
        <p:nvSpPr>
          <p:cNvPr id="4" name="직사각형 3"/>
          <p:cNvSpPr/>
          <p:nvPr/>
        </p:nvSpPr>
        <p:spPr>
          <a:xfrm>
            <a:off x="540152" y="6233070"/>
            <a:ext cx="11414782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ko-KR" sz="1600" dirty="0"/>
              <a:t>Create project and import input files. The user must create a project and specify the data files in </a:t>
            </a:r>
            <a:r>
              <a:rPr lang="en-GB" altLang="ko-KR" sz="1600" dirty="0" err="1"/>
              <a:t>fastq</a:t>
            </a:r>
            <a:r>
              <a:rPr lang="en-GB" altLang="ko-KR" sz="1600" dirty="0"/>
              <a:t> format for sequencing reads and in FASTA format for a reference file</a:t>
            </a:r>
            <a:endParaRPr lang="ko-KR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7225293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D3E4D02B-D6E5-A54F-9FCE-6B9017690DDC}"/>
              </a:ext>
            </a:extLst>
          </p:cNvPr>
          <p:cNvPicPr>
            <a:picLocks noChangeAspect="1"/>
          </p:cNvPicPr>
          <p:nvPr/>
        </p:nvPicPr>
        <p:blipFill rotWithShape="1">
          <a:blip r:embed="rId2" r:link="rId3"/>
          <a:srcRect l="19345" t="16762" r="8751" b="11238"/>
          <a:stretch>
            <a:fillRect/>
          </a:stretch>
        </p:blipFill>
        <p:spPr>
          <a:xfrm>
            <a:off x="1316882" y="0"/>
            <a:ext cx="9558236" cy="607229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03200" y="6317735"/>
            <a:ext cx="3497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 smtClean="0"/>
              <a:t>b</a:t>
            </a:r>
            <a:endParaRPr lang="ko-KR" altLang="en-US" sz="2400" b="1" dirty="0"/>
          </a:p>
        </p:txBody>
      </p:sp>
      <p:sp>
        <p:nvSpPr>
          <p:cNvPr id="2" name="직사각형 1"/>
          <p:cNvSpPr/>
          <p:nvPr/>
        </p:nvSpPr>
        <p:spPr>
          <a:xfrm>
            <a:off x="812800" y="6107297"/>
            <a:ext cx="10922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ko-KR" dirty="0"/>
              <a:t>Step-by-step mode of the NGS_SNP </a:t>
            </a:r>
            <a:r>
              <a:rPr lang="en-GB" altLang="ko-KR" dirty="0" err="1"/>
              <a:t>analyzer</a:t>
            </a:r>
            <a:r>
              <a:rPr lang="en-GB" altLang="ko-KR" dirty="0"/>
              <a:t>: the user can change the options at every step and observe the results from the log window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748162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3">
            <a:extLst>
              <a:ext uri="{FF2B5EF4-FFF2-40B4-BE49-F238E27FC236}">
                <a16:creationId xmlns:a16="http://schemas.microsoft.com/office/drawing/2014/main" xmlns="" id="{0F5FDDF2-AC76-2048-9B21-F2B4948FC0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1186" y="0"/>
            <a:ext cx="11489629" cy="622354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03200" y="6317735"/>
            <a:ext cx="3129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 smtClean="0"/>
              <a:t>c</a:t>
            </a:r>
            <a:endParaRPr lang="ko-KR" altLang="en-US" sz="2400" b="1" dirty="0"/>
          </a:p>
        </p:txBody>
      </p:sp>
      <p:sp>
        <p:nvSpPr>
          <p:cNvPr id="3" name="직사각형 2"/>
          <p:cNvSpPr/>
          <p:nvPr/>
        </p:nvSpPr>
        <p:spPr>
          <a:xfrm>
            <a:off x="728132" y="6205433"/>
            <a:ext cx="1121869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ko-KR" dirty="0"/>
              <a:t>One-step mode of the NGS_SNP </a:t>
            </a:r>
            <a:r>
              <a:rPr lang="en-GB" altLang="ko-KR" dirty="0" err="1"/>
              <a:t>analyzer</a:t>
            </a:r>
            <a:r>
              <a:rPr lang="en-GB" altLang="ko-KR" dirty="0"/>
              <a:t>: the user can change the options at every step and observe the results from the log window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530531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3</Words>
  <Application>Microsoft Office PowerPoint</Application>
  <PresentationFormat>사용자 지정</PresentationFormat>
  <Paragraphs>6</Paragraphs>
  <Slides>3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4" baseType="lpstr">
      <vt:lpstr>Office Theme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권태수</dc:creator>
  <cp:lastModifiedBy>joshuakwon</cp:lastModifiedBy>
  <cp:revision>6</cp:revision>
  <dcterms:created xsi:type="dcterms:W3CDTF">2018-08-31T02:00:28Z</dcterms:created>
  <dcterms:modified xsi:type="dcterms:W3CDTF">2020-06-24T07:13:27Z</dcterms:modified>
</cp:coreProperties>
</file>